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Override1.xml" ContentType="application/vnd.openxmlformats-officedocument.themeOverrid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65" r:id="rId3"/>
    <p:sldId id="260" r:id="rId4"/>
    <p:sldId id="261" r:id="rId5"/>
    <p:sldId id="263" r:id="rId6"/>
    <p:sldId id="262" r:id="rId7"/>
    <p:sldId id="264" r:id="rId8"/>
  </p:sldIdLst>
  <p:sldSz cx="9721850" cy="6840538"/>
  <p:notesSz cx="9144000" cy="6858000"/>
  <p:defaultTextStyle>
    <a:defPPr>
      <a:defRPr lang="zh-CN"/>
    </a:defPPr>
    <a:lvl1pPr marL="0" algn="l" defTabSz="914226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57113" algn="l" defTabSz="914226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914226" algn="l" defTabSz="914226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371341" algn="l" defTabSz="914226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828453" algn="l" defTabSz="914226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285566" algn="l" defTabSz="914226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742679" algn="l" defTabSz="914226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3199794" algn="l" defTabSz="914226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656907" algn="l" defTabSz="914226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038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5764" autoAdjust="0"/>
  </p:normalViewPr>
  <p:slideViewPr>
    <p:cSldViewPr>
      <p:cViewPr varScale="1">
        <p:scale>
          <a:sx n="100" d="100"/>
          <a:sy n="100" d="100"/>
        </p:scale>
        <p:origin x="-114" y="-198"/>
      </p:cViewPr>
      <p:guideLst>
        <p:guide orient="horz" pos="2155"/>
        <p:guide pos="306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2C194E-4AEE-46B3-8212-788F320DC8BF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744788" y="514350"/>
            <a:ext cx="3654425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4CF311-182D-4CEC-A4B0-E3C495C508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979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2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13" algn="l" defTabSz="91422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26" algn="l" defTabSz="91422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41" algn="l" defTabSz="91422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453" algn="l" defTabSz="91422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566" algn="l" defTabSz="91422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679" algn="l" defTabSz="91422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794" algn="l" defTabSz="91422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907" algn="l" defTabSz="91422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744788" y="514350"/>
            <a:ext cx="3654425" cy="257175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2A85D7-B278-4D8F-BA36-CC5220C14963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37811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4CF311-182D-4CEC-A4B0-E3C495C5087D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73528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29140" y="2125008"/>
            <a:ext cx="8263573" cy="146628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458278" y="3876305"/>
            <a:ext cx="6805295" cy="174813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4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6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7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9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2566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7422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048342" y="273948"/>
            <a:ext cx="2187416" cy="583662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86092" y="273948"/>
            <a:ext cx="6400218" cy="583662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7020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573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67959" y="4395683"/>
            <a:ext cx="8263573" cy="1358607"/>
          </a:xfrm>
        </p:spPr>
        <p:txBody>
          <a:bodyPr anchor="t"/>
          <a:lstStyle>
            <a:lvl1pPr algn="l">
              <a:defRPr sz="41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67959" y="2899318"/>
            <a:ext cx="8263573" cy="1496368"/>
          </a:xfrm>
        </p:spPr>
        <p:txBody>
          <a:bodyPr anchor="b"/>
          <a:lstStyle>
            <a:lvl1pPr marL="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1pPr>
            <a:lvl2pPr marL="45711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91422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4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45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6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79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90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269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86094" y="1596127"/>
            <a:ext cx="4293817" cy="4514441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941941" y="1596127"/>
            <a:ext cx="4293817" cy="4514441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7798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86093" y="1531208"/>
            <a:ext cx="4295505" cy="638136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57113" indent="0">
              <a:buNone/>
              <a:defRPr sz="1900" b="1"/>
            </a:lvl2pPr>
            <a:lvl3pPr marL="914226" indent="0">
              <a:buNone/>
              <a:defRPr sz="1700" b="1"/>
            </a:lvl3pPr>
            <a:lvl4pPr marL="1371341" indent="0">
              <a:buNone/>
              <a:defRPr sz="1600" b="1"/>
            </a:lvl4pPr>
            <a:lvl5pPr marL="1828453" indent="0">
              <a:buNone/>
              <a:defRPr sz="1600" b="1"/>
            </a:lvl5pPr>
            <a:lvl6pPr marL="2285566" indent="0">
              <a:buNone/>
              <a:defRPr sz="1600" b="1"/>
            </a:lvl6pPr>
            <a:lvl7pPr marL="2742679" indent="0">
              <a:buNone/>
              <a:defRPr sz="1600" b="1"/>
            </a:lvl7pPr>
            <a:lvl8pPr marL="3199794" indent="0">
              <a:buNone/>
              <a:defRPr sz="1600" b="1"/>
            </a:lvl8pPr>
            <a:lvl9pPr marL="3656907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86093" y="2169344"/>
            <a:ext cx="4295505" cy="3941224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938565" y="1531208"/>
            <a:ext cx="4297193" cy="638136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57113" indent="0">
              <a:buNone/>
              <a:defRPr sz="1900" b="1"/>
            </a:lvl2pPr>
            <a:lvl3pPr marL="914226" indent="0">
              <a:buNone/>
              <a:defRPr sz="1700" b="1"/>
            </a:lvl3pPr>
            <a:lvl4pPr marL="1371341" indent="0">
              <a:buNone/>
              <a:defRPr sz="1600" b="1"/>
            </a:lvl4pPr>
            <a:lvl5pPr marL="1828453" indent="0">
              <a:buNone/>
              <a:defRPr sz="1600" b="1"/>
            </a:lvl5pPr>
            <a:lvl6pPr marL="2285566" indent="0">
              <a:buNone/>
              <a:defRPr sz="1600" b="1"/>
            </a:lvl6pPr>
            <a:lvl7pPr marL="2742679" indent="0">
              <a:buNone/>
              <a:defRPr sz="1600" b="1"/>
            </a:lvl7pPr>
            <a:lvl8pPr marL="3199794" indent="0">
              <a:buNone/>
              <a:defRPr sz="1600" b="1"/>
            </a:lvl8pPr>
            <a:lvl9pPr marL="3656907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938565" y="2169344"/>
            <a:ext cx="4297193" cy="3941224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9128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8989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8433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86094" y="272358"/>
            <a:ext cx="3198422" cy="1159091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00974" y="272362"/>
            <a:ext cx="5434784" cy="5838210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3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86094" y="1431453"/>
            <a:ext cx="3198422" cy="4679119"/>
          </a:xfrm>
        </p:spPr>
        <p:txBody>
          <a:bodyPr/>
          <a:lstStyle>
            <a:lvl1pPr marL="0" indent="0">
              <a:buNone/>
              <a:defRPr sz="1400"/>
            </a:lvl1pPr>
            <a:lvl2pPr marL="457113" indent="0">
              <a:buNone/>
              <a:defRPr sz="1200"/>
            </a:lvl2pPr>
            <a:lvl3pPr marL="914226" indent="0">
              <a:buNone/>
              <a:defRPr sz="1000"/>
            </a:lvl3pPr>
            <a:lvl4pPr marL="1371341" indent="0">
              <a:buNone/>
              <a:defRPr sz="1000"/>
            </a:lvl4pPr>
            <a:lvl5pPr marL="1828453" indent="0">
              <a:buNone/>
              <a:defRPr sz="1000"/>
            </a:lvl5pPr>
            <a:lvl6pPr marL="2285566" indent="0">
              <a:buNone/>
              <a:defRPr sz="1000"/>
            </a:lvl6pPr>
            <a:lvl7pPr marL="2742679" indent="0">
              <a:buNone/>
              <a:defRPr sz="1000"/>
            </a:lvl7pPr>
            <a:lvl8pPr marL="3199794" indent="0">
              <a:buNone/>
              <a:defRPr sz="1000"/>
            </a:lvl8pPr>
            <a:lvl9pPr marL="3656907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211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905551" y="4788381"/>
            <a:ext cx="5833110" cy="565295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905551" y="611213"/>
            <a:ext cx="5833110" cy="4104323"/>
          </a:xfrm>
        </p:spPr>
        <p:txBody>
          <a:bodyPr/>
          <a:lstStyle>
            <a:lvl1pPr marL="0" indent="0">
              <a:buNone/>
              <a:defRPr sz="3100"/>
            </a:lvl1pPr>
            <a:lvl2pPr marL="457113" indent="0">
              <a:buNone/>
              <a:defRPr sz="2700"/>
            </a:lvl2pPr>
            <a:lvl3pPr marL="914226" indent="0">
              <a:buNone/>
              <a:defRPr sz="2300"/>
            </a:lvl3pPr>
            <a:lvl4pPr marL="1371341" indent="0">
              <a:buNone/>
              <a:defRPr sz="1900"/>
            </a:lvl4pPr>
            <a:lvl5pPr marL="1828453" indent="0">
              <a:buNone/>
              <a:defRPr sz="1900"/>
            </a:lvl5pPr>
            <a:lvl6pPr marL="2285566" indent="0">
              <a:buNone/>
              <a:defRPr sz="1900"/>
            </a:lvl6pPr>
            <a:lvl7pPr marL="2742679" indent="0">
              <a:buNone/>
              <a:defRPr sz="1900"/>
            </a:lvl7pPr>
            <a:lvl8pPr marL="3199794" indent="0">
              <a:buNone/>
              <a:defRPr sz="1900"/>
            </a:lvl8pPr>
            <a:lvl9pPr marL="3656907" indent="0">
              <a:buNone/>
              <a:defRPr sz="19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905551" y="5353676"/>
            <a:ext cx="5833110" cy="802814"/>
          </a:xfrm>
        </p:spPr>
        <p:txBody>
          <a:bodyPr/>
          <a:lstStyle>
            <a:lvl1pPr marL="0" indent="0">
              <a:buNone/>
              <a:defRPr sz="1400"/>
            </a:lvl1pPr>
            <a:lvl2pPr marL="457113" indent="0">
              <a:buNone/>
              <a:defRPr sz="1200"/>
            </a:lvl2pPr>
            <a:lvl3pPr marL="914226" indent="0">
              <a:buNone/>
              <a:defRPr sz="1000"/>
            </a:lvl3pPr>
            <a:lvl4pPr marL="1371341" indent="0">
              <a:buNone/>
              <a:defRPr sz="1000"/>
            </a:lvl4pPr>
            <a:lvl5pPr marL="1828453" indent="0">
              <a:buNone/>
              <a:defRPr sz="1000"/>
            </a:lvl5pPr>
            <a:lvl6pPr marL="2285566" indent="0">
              <a:buNone/>
              <a:defRPr sz="1000"/>
            </a:lvl6pPr>
            <a:lvl7pPr marL="2742679" indent="0">
              <a:buNone/>
              <a:defRPr sz="1000"/>
            </a:lvl7pPr>
            <a:lvl8pPr marL="3199794" indent="0">
              <a:buNone/>
              <a:defRPr sz="1000"/>
            </a:lvl8pPr>
            <a:lvl9pPr marL="3656907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100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86094" y="273936"/>
            <a:ext cx="8749665" cy="1140090"/>
          </a:xfrm>
          <a:prstGeom prst="rect">
            <a:avLst/>
          </a:prstGeom>
        </p:spPr>
        <p:txBody>
          <a:bodyPr vert="horz" lIns="91422" tIns="45711" rIns="91422" bIns="45711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86094" y="1596127"/>
            <a:ext cx="8749665" cy="4514441"/>
          </a:xfrm>
          <a:prstGeom prst="rect">
            <a:avLst/>
          </a:prstGeom>
        </p:spPr>
        <p:txBody>
          <a:bodyPr vert="horz" lIns="91422" tIns="45711" rIns="91422" bIns="45711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86094" y="6340176"/>
            <a:ext cx="2268431" cy="364193"/>
          </a:xfrm>
          <a:prstGeom prst="rect">
            <a:avLst/>
          </a:prstGeom>
        </p:spPr>
        <p:txBody>
          <a:bodyPr vert="horz" lIns="91422" tIns="45711" rIns="91422" bIns="45711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D80CD-1FE2-4DA3-82A2-D7F5C2B66F77}" type="datetimeFigureOut">
              <a:rPr lang="zh-CN" altLang="en-US" smtClean="0"/>
              <a:t>2018/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321633" y="6340176"/>
            <a:ext cx="3078586" cy="364193"/>
          </a:xfrm>
          <a:prstGeom prst="rect">
            <a:avLst/>
          </a:prstGeom>
        </p:spPr>
        <p:txBody>
          <a:bodyPr vert="horz" lIns="91422" tIns="45711" rIns="91422" bIns="45711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967327" y="6340176"/>
            <a:ext cx="2268431" cy="364193"/>
          </a:xfrm>
          <a:prstGeom prst="rect">
            <a:avLst/>
          </a:prstGeom>
        </p:spPr>
        <p:txBody>
          <a:bodyPr vert="horz" lIns="91422" tIns="45711" rIns="91422" bIns="45711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DDBEF-1EF4-4B37-9D3E-82B3DFD4D7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9073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26" rtl="0" eaLnBrk="1" latinLnBrk="0" hangingPunct="1">
        <a:spcBef>
          <a:spcPct val="0"/>
        </a:spcBef>
        <a:buNone/>
        <a:defRPr sz="4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35" indent="-342835" algn="l" defTabSz="914226" rtl="0" eaLnBrk="1" latinLnBrk="0" hangingPunct="1">
        <a:spcBef>
          <a:spcPct val="20000"/>
        </a:spcBef>
        <a:buFont typeface="Arial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09" indent="-285697" algn="l" defTabSz="914226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84" indent="-228556" algn="l" defTabSz="914226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97" indent="-228556" algn="l" defTabSz="914226" rtl="0" eaLnBrk="1" latinLnBrk="0" hangingPunct="1">
        <a:spcBef>
          <a:spcPct val="20000"/>
        </a:spcBef>
        <a:buFont typeface="Arial" pitchFamily="34" charset="0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10" indent="-228556" algn="l" defTabSz="914226" rtl="0" eaLnBrk="1" latinLnBrk="0" hangingPunct="1">
        <a:spcBef>
          <a:spcPct val="20000"/>
        </a:spcBef>
        <a:buFont typeface="Arial" pitchFamily="34" charset="0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123" indent="-228556" algn="l" defTabSz="914226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238" indent="-228556" algn="l" defTabSz="914226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351" indent="-228556" algn="l" defTabSz="914226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463" indent="-228556" algn="l" defTabSz="914226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226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13" algn="l" defTabSz="914226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26" algn="l" defTabSz="914226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41" algn="l" defTabSz="914226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53" algn="l" defTabSz="914226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566" algn="l" defTabSz="914226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679" algn="l" defTabSz="914226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794" algn="l" defTabSz="914226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907" algn="l" defTabSz="914226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9.tiff"/><Relationship Id="rId2" Type="http://schemas.openxmlformats.org/officeDocument/2006/relationships/slideLayout" Target="../slideLayouts/slideLayout1.xml"/><Relationship Id="rId1" Type="http://schemas.openxmlformats.org/officeDocument/2006/relationships/themeOverride" Target="../theme/themeOverride1.xml"/><Relationship Id="rId6" Type="http://schemas.openxmlformats.org/officeDocument/2006/relationships/image" Target="../media/image8.tiff"/><Relationship Id="rId11" Type="http://schemas.openxmlformats.org/officeDocument/2006/relationships/image" Target="../media/image13.png"/><Relationship Id="rId5" Type="http://schemas.openxmlformats.org/officeDocument/2006/relationships/image" Target="../media/image7.tiff"/><Relationship Id="rId10" Type="http://schemas.openxmlformats.org/officeDocument/2006/relationships/image" Target="../media/image12.png"/><Relationship Id="rId4" Type="http://schemas.openxmlformats.org/officeDocument/2006/relationships/image" Target="../media/image6.tiff"/><Relationship Id="rId9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5.tiff"/><Relationship Id="rId7" Type="http://schemas.microsoft.com/office/2007/relationships/hdphoto" Target="../media/hdphoto1.wdp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tiff"/><Relationship Id="rId9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9.png"/><Relationship Id="rId18" Type="http://schemas.microsoft.com/office/2007/relationships/hdphoto" Target="../media/hdphoto5.wdp"/><Relationship Id="rId26" Type="http://schemas.openxmlformats.org/officeDocument/2006/relationships/image" Target="../media/image37.png"/><Relationship Id="rId39" Type="http://schemas.openxmlformats.org/officeDocument/2006/relationships/image" Target="../media/image47.png"/><Relationship Id="rId3" Type="http://schemas.openxmlformats.org/officeDocument/2006/relationships/image" Target="../media/image22.png"/><Relationship Id="rId21" Type="http://schemas.microsoft.com/office/2007/relationships/hdphoto" Target="../media/hdphoto6.wdp"/><Relationship Id="rId34" Type="http://schemas.openxmlformats.org/officeDocument/2006/relationships/image" Target="../media/image42.png"/><Relationship Id="rId42" Type="http://schemas.microsoft.com/office/2007/relationships/hdphoto" Target="../media/hdphoto11.wdp"/><Relationship Id="rId47" Type="http://schemas.microsoft.com/office/2007/relationships/hdphoto" Target="../media/hdphoto13.wdp"/><Relationship Id="rId7" Type="http://schemas.openxmlformats.org/officeDocument/2006/relationships/image" Target="../media/image25.png"/><Relationship Id="rId12" Type="http://schemas.openxmlformats.org/officeDocument/2006/relationships/image" Target="../media/image14.tiff"/><Relationship Id="rId17" Type="http://schemas.openxmlformats.org/officeDocument/2006/relationships/image" Target="../media/image32.png"/><Relationship Id="rId25" Type="http://schemas.openxmlformats.org/officeDocument/2006/relationships/image" Target="../media/image36.png"/><Relationship Id="rId33" Type="http://schemas.microsoft.com/office/2007/relationships/hdphoto" Target="../media/hdphoto10.wdp"/><Relationship Id="rId38" Type="http://schemas.openxmlformats.org/officeDocument/2006/relationships/image" Target="../media/image46.png"/><Relationship Id="rId46" Type="http://schemas.openxmlformats.org/officeDocument/2006/relationships/image" Target="../media/image52.png"/><Relationship Id="rId2" Type="http://schemas.openxmlformats.org/officeDocument/2006/relationships/image" Target="../media/image21.png"/><Relationship Id="rId16" Type="http://schemas.microsoft.com/office/2007/relationships/hdphoto" Target="../media/hdphoto4.wdp"/><Relationship Id="rId20" Type="http://schemas.openxmlformats.org/officeDocument/2006/relationships/image" Target="../media/image33.png"/><Relationship Id="rId29" Type="http://schemas.openxmlformats.org/officeDocument/2006/relationships/image" Target="../media/image39.png"/><Relationship Id="rId41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11" Type="http://schemas.microsoft.com/office/2007/relationships/hdphoto" Target="../media/hdphoto3.wdp"/><Relationship Id="rId24" Type="http://schemas.microsoft.com/office/2007/relationships/hdphoto" Target="../media/hdphoto7.wdp"/><Relationship Id="rId32" Type="http://schemas.openxmlformats.org/officeDocument/2006/relationships/image" Target="../media/image41.png"/><Relationship Id="rId37" Type="http://schemas.openxmlformats.org/officeDocument/2006/relationships/image" Target="../media/image45.png"/><Relationship Id="rId40" Type="http://schemas.openxmlformats.org/officeDocument/2006/relationships/image" Target="../media/image48.png"/><Relationship Id="rId45" Type="http://schemas.openxmlformats.org/officeDocument/2006/relationships/image" Target="../media/image51.png"/><Relationship Id="rId5" Type="http://schemas.microsoft.com/office/2007/relationships/hdphoto" Target="../media/hdphoto2.wdp"/><Relationship Id="rId15" Type="http://schemas.openxmlformats.org/officeDocument/2006/relationships/image" Target="../media/image31.png"/><Relationship Id="rId23" Type="http://schemas.openxmlformats.org/officeDocument/2006/relationships/image" Target="../media/image35.png"/><Relationship Id="rId28" Type="http://schemas.microsoft.com/office/2007/relationships/hdphoto" Target="../media/hdphoto8.wdp"/><Relationship Id="rId36" Type="http://schemas.openxmlformats.org/officeDocument/2006/relationships/image" Target="../media/image44.png"/><Relationship Id="rId49" Type="http://schemas.openxmlformats.org/officeDocument/2006/relationships/image" Target="../media/image54.png"/><Relationship Id="rId10" Type="http://schemas.openxmlformats.org/officeDocument/2006/relationships/image" Target="../media/image28.png"/><Relationship Id="rId19" Type="http://schemas.openxmlformats.org/officeDocument/2006/relationships/image" Target="../media/image15.tiff"/><Relationship Id="rId31" Type="http://schemas.openxmlformats.org/officeDocument/2006/relationships/image" Target="../media/image40.jpeg"/><Relationship Id="rId44" Type="http://schemas.microsoft.com/office/2007/relationships/hdphoto" Target="../media/hdphoto12.wdp"/><Relationship Id="rId4" Type="http://schemas.openxmlformats.org/officeDocument/2006/relationships/image" Target="../media/image23.png"/><Relationship Id="rId9" Type="http://schemas.openxmlformats.org/officeDocument/2006/relationships/image" Target="../media/image27.png"/><Relationship Id="rId14" Type="http://schemas.openxmlformats.org/officeDocument/2006/relationships/image" Target="../media/image30.png"/><Relationship Id="rId22" Type="http://schemas.openxmlformats.org/officeDocument/2006/relationships/image" Target="../media/image34.png"/><Relationship Id="rId27" Type="http://schemas.openxmlformats.org/officeDocument/2006/relationships/image" Target="../media/image38.png"/><Relationship Id="rId30" Type="http://schemas.microsoft.com/office/2007/relationships/hdphoto" Target="../media/hdphoto9.wdp"/><Relationship Id="rId35" Type="http://schemas.openxmlformats.org/officeDocument/2006/relationships/image" Target="../media/image43.png"/><Relationship Id="rId43" Type="http://schemas.openxmlformats.org/officeDocument/2006/relationships/image" Target="../media/image50.png"/><Relationship Id="rId48" Type="http://schemas.openxmlformats.org/officeDocument/2006/relationships/image" Target="../media/image53.png"/><Relationship Id="rId8" Type="http://schemas.openxmlformats.org/officeDocument/2006/relationships/image" Target="../media/image26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4.wdp"/><Relationship Id="rId3" Type="http://schemas.openxmlformats.org/officeDocument/2006/relationships/image" Target="../media/image55.png"/><Relationship Id="rId7" Type="http://schemas.openxmlformats.org/officeDocument/2006/relationships/image" Target="../media/image5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8.png"/><Relationship Id="rId5" Type="http://schemas.openxmlformats.org/officeDocument/2006/relationships/image" Target="../media/image57.png"/><Relationship Id="rId10" Type="http://schemas.openxmlformats.org/officeDocument/2006/relationships/image" Target="../media/image61.png"/><Relationship Id="rId4" Type="http://schemas.openxmlformats.org/officeDocument/2006/relationships/image" Target="../media/image56.png"/><Relationship Id="rId9" Type="http://schemas.openxmlformats.org/officeDocument/2006/relationships/image" Target="../media/image60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jpeg"/><Relationship Id="rId13" Type="http://schemas.openxmlformats.org/officeDocument/2006/relationships/image" Target="../media/image71.png"/><Relationship Id="rId18" Type="http://schemas.openxmlformats.org/officeDocument/2006/relationships/image" Target="../media/image76.png"/><Relationship Id="rId26" Type="http://schemas.openxmlformats.org/officeDocument/2006/relationships/image" Target="../media/image84.jpeg"/><Relationship Id="rId3" Type="http://schemas.openxmlformats.org/officeDocument/2006/relationships/image" Target="../media/image63.png"/><Relationship Id="rId21" Type="http://schemas.openxmlformats.org/officeDocument/2006/relationships/image" Target="../media/image79.png"/><Relationship Id="rId34" Type="http://schemas.openxmlformats.org/officeDocument/2006/relationships/image" Target="../media/image92.jpeg"/><Relationship Id="rId7" Type="http://schemas.microsoft.com/office/2007/relationships/hdphoto" Target="../media/hdphoto15.wdp"/><Relationship Id="rId12" Type="http://schemas.openxmlformats.org/officeDocument/2006/relationships/image" Target="../media/image70.png"/><Relationship Id="rId17" Type="http://schemas.openxmlformats.org/officeDocument/2006/relationships/image" Target="../media/image75.png"/><Relationship Id="rId25" Type="http://schemas.openxmlformats.org/officeDocument/2006/relationships/image" Target="../media/image83.png"/><Relationship Id="rId33" Type="http://schemas.openxmlformats.org/officeDocument/2006/relationships/image" Target="../media/image91.png"/><Relationship Id="rId38" Type="http://schemas.openxmlformats.org/officeDocument/2006/relationships/image" Target="../media/image96.png"/><Relationship Id="rId2" Type="http://schemas.openxmlformats.org/officeDocument/2006/relationships/image" Target="../media/image62.png"/><Relationship Id="rId16" Type="http://schemas.openxmlformats.org/officeDocument/2006/relationships/image" Target="../media/image74.png"/><Relationship Id="rId20" Type="http://schemas.openxmlformats.org/officeDocument/2006/relationships/image" Target="../media/image78.png"/><Relationship Id="rId29" Type="http://schemas.openxmlformats.org/officeDocument/2006/relationships/image" Target="../media/image8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png"/><Relationship Id="rId11" Type="http://schemas.openxmlformats.org/officeDocument/2006/relationships/image" Target="../media/image69.png"/><Relationship Id="rId24" Type="http://schemas.openxmlformats.org/officeDocument/2006/relationships/image" Target="../media/image82.png"/><Relationship Id="rId32" Type="http://schemas.openxmlformats.org/officeDocument/2006/relationships/image" Target="../media/image90.jpeg"/><Relationship Id="rId37" Type="http://schemas.openxmlformats.org/officeDocument/2006/relationships/image" Target="../media/image95.png"/><Relationship Id="rId5" Type="http://schemas.openxmlformats.org/officeDocument/2006/relationships/image" Target="../media/image65.png"/><Relationship Id="rId15" Type="http://schemas.openxmlformats.org/officeDocument/2006/relationships/image" Target="../media/image73.png"/><Relationship Id="rId23" Type="http://schemas.openxmlformats.org/officeDocument/2006/relationships/image" Target="../media/image81.jpeg"/><Relationship Id="rId28" Type="http://schemas.openxmlformats.org/officeDocument/2006/relationships/image" Target="../media/image86.png"/><Relationship Id="rId36" Type="http://schemas.openxmlformats.org/officeDocument/2006/relationships/image" Target="../media/image94.jpeg"/><Relationship Id="rId10" Type="http://schemas.openxmlformats.org/officeDocument/2006/relationships/image" Target="../media/image68.png"/><Relationship Id="rId19" Type="http://schemas.openxmlformats.org/officeDocument/2006/relationships/image" Target="../media/image77.png"/><Relationship Id="rId31" Type="http://schemas.openxmlformats.org/officeDocument/2006/relationships/image" Target="../media/image89.png"/><Relationship Id="rId4" Type="http://schemas.openxmlformats.org/officeDocument/2006/relationships/image" Target="../media/image64.jpeg"/><Relationship Id="rId9" Type="http://schemas.openxmlformats.org/officeDocument/2006/relationships/image" Target="../media/image67.jpeg"/><Relationship Id="rId14" Type="http://schemas.openxmlformats.org/officeDocument/2006/relationships/image" Target="../media/image72.png"/><Relationship Id="rId22" Type="http://schemas.openxmlformats.org/officeDocument/2006/relationships/image" Target="../media/image80.png"/><Relationship Id="rId27" Type="http://schemas.openxmlformats.org/officeDocument/2006/relationships/image" Target="../media/image85.png"/><Relationship Id="rId30" Type="http://schemas.openxmlformats.org/officeDocument/2006/relationships/image" Target="../media/image88.jpeg"/><Relationship Id="rId35" Type="http://schemas.openxmlformats.org/officeDocument/2006/relationships/image" Target="../media/image9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451916" y="3672541"/>
            <a:ext cx="842144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pPr algn="ctr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431705" y="3101508"/>
            <a:ext cx="899716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pPr algn="ctr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k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80405" y="2700189"/>
            <a:ext cx="918702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PV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80405" y="4154863"/>
            <a:ext cx="918702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84859" y="685191"/>
            <a:ext cx="8799274" cy="567918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sz="3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3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endParaRPr lang="zh-CN" altLang="en-US" sz="3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5294060" y="2793595"/>
            <a:ext cx="3868602" cy="1274746"/>
            <a:chOff x="1250543" y="3107749"/>
            <a:chExt cx="6691384" cy="2232128"/>
          </a:xfrm>
        </p:grpSpPr>
        <p:pic>
          <p:nvPicPr>
            <p:cNvPr id="10" name="Picture 8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04109" y="3179877"/>
              <a:ext cx="2160000" cy="2160000"/>
            </a:xfrm>
            <a:prstGeom prst="rect">
              <a:avLst/>
            </a:prstGeom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9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81927" y="3179877"/>
              <a:ext cx="2160000" cy="216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10"/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42863" y="3179877"/>
              <a:ext cx="2160000" cy="216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1" name="TextBox 50"/>
            <p:cNvSpPr txBox="1"/>
            <p:nvPr/>
          </p:nvSpPr>
          <p:spPr>
            <a:xfrm>
              <a:off x="1250543" y="3137367"/>
              <a:ext cx="1038711" cy="483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solidFill>
                    <a:srgbClr val="1038F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PI</a:t>
              </a:r>
              <a:endParaRPr lang="zh-CN" altLang="en-US" sz="1200" dirty="0">
                <a:solidFill>
                  <a:srgbClr val="1038F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470737" y="3107749"/>
              <a:ext cx="1224136" cy="483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RPV4</a:t>
              </a:r>
              <a:endParaRPr lang="zh-CN" altLang="en-US" sz="12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700480" y="3107749"/>
              <a:ext cx="2241447" cy="806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b="1" i="1">
                  <a:solidFill>
                    <a:srgbClr val="00B050"/>
                  </a:solidFill>
                </a:defRPr>
              </a:lvl1pPr>
            </a:lstStyle>
            <a:p>
              <a:r>
                <a:rPr lang="en-US" altLang="zh-CN" sz="1200" dirty="0">
                  <a:solidFill>
                    <a:srgbClr val="1038F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PI</a:t>
              </a:r>
              <a:r>
                <a:rPr lang="en-US" altLang="zh-CN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PV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2968946" y="5229200"/>
              <a:ext cx="3816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286407" y="2268141"/>
            <a:ext cx="453817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170608" y="2282655"/>
            <a:ext cx="453817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 rot="19228726">
            <a:off x="995209" y="1758697"/>
            <a:ext cx="18934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RCECs/Scrambled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9268910">
            <a:off x="1899031" y="1625500"/>
            <a:ext cx="2088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RCECs/shRN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9268910">
            <a:off x="3555215" y="1590971"/>
            <a:ext cx="2088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3/empty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cto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9268910">
            <a:off x="2743995" y="1590971"/>
            <a:ext cx="2088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3/TRPV4 plasmid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8303" y="2519683"/>
            <a:ext cx="3343402" cy="19807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448882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11"/>
          <a:stretch/>
        </p:blipFill>
        <p:spPr bwMode="auto">
          <a:xfrm rot="189788">
            <a:off x="248307" y="544644"/>
            <a:ext cx="7268470" cy="49637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矩形 2"/>
          <p:cNvSpPr/>
          <p:nvPr/>
        </p:nvSpPr>
        <p:spPr>
          <a:xfrm>
            <a:off x="4298929" y="2224269"/>
            <a:ext cx="2664296" cy="216024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963225" y="2197707"/>
            <a:ext cx="2088232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The image in the red box is what I used in the article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457158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30238" y="1756922"/>
            <a:ext cx="3399250" cy="2491103"/>
            <a:chOff x="3874464" y="1813564"/>
            <a:chExt cx="3994266" cy="3080396"/>
          </a:xfrm>
        </p:grpSpPr>
        <p:grpSp>
          <p:nvGrpSpPr>
            <p:cNvPr id="36" name="组合 35"/>
            <p:cNvGrpSpPr/>
            <p:nvPr/>
          </p:nvGrpSpPr>
          <p:grpSpPr>
            <a:xfrm>
              <a:off x="4346834" y="2196892"/>
              <a:ext cx="3339255" cy="2600259"/>
              <a:chOff x="5479758" y="3703766"/>
              <a:chExt cx="3384256" cy="2553814"/>
            </a:xfrm>
          </p:grpSpPr>
          <p:pic>
            <p:nvPicPr>
              <p:cNvPr id="37" name="图片 36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79758" y="3703766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38" name="图片 3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31886" y="3703766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39" name="Picture 8" descr="C:\Users\DELL\Desktop\新建文件夹\Series009_t33.tif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784014" y="5177580"/>
                <a:ext cx="1080000" cy="108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0" name="Picture 9" descr="C:\Users\DELL\Desktop\新建文件夹\Series009_t00.tif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631886" y="5177580"/>
                <a:ext cx="1080000" cy="108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1" name="Picture 10" descr="C:\Users\DELL\Desktop\新建文件夹\Series009_t06.tif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79758" y="5177580"/>
                <a:ext cx="1080000" cy="108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2" name="Picture 11" descr="C:\Users\DELL\Desktop\新建文件夹\F-200-1_t18_ch00.tif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784014" y="3703766"/>
                <a:ext cx="1080000" cy="108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43" name="直接连接符 42"/>
              <p:cNvCxnSpPr/>
              <p:nvPr/>
            </p:nvCxnSpPr>
            <p:spPr>
              <a:xfrm>
                <a:off x="5551646" y="6186859"/>
                <a:ext cx="192347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accent3"/>
              </a:lnRef>
              <a:fillRef idx="0">
                <a:schemeClr val="accent3"/>
              </a:fillRef>
              <a:effectRef idx="2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>
              <a:xfrm>
                <a:off x="5551766" y="4711878"/>
                <a:ext cx="192347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accent3"/>
              </a:lnRef>
              <a:fillRef idx="0">
                <a:schemeClr val="accent3"/>
              </a:fillRef>
              <a:effectRef idx="2">
                <a:schemeClr val="accent3"/>
              </a:effectRef>
              <a:fontRef idx="minor">
                <a:schemeClr val="tx1"/>
              </a:fontRef>
            </p:style>
          </p:cxnSp>
        </p:grpSp>
        <p:sp>
          <p:nvSpPr>
            <p:cNvPr id="47" name="TextBox 46"/>
            <p:cNvSpPr txBox="1"/>
            <p:nvPr/>
          </p:nvSpPr>
          <p:spPr>
            <a:xfrm>
              <a:off x="7076721" y="4456289"/>
              <a:ext cx="792009" cy="437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schemeClr val="bg1"/>
                  </a:solidFill>
                </a:rPr>
                <a:t>150s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983547" y="4456289"/>
              <a:ext cx="792009" cy="4365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chemeClr val="bg1"/>
                  </a:solidFill>
                </a:rPr>
                <a:t> </a:t>
              </a:r>
              <a:r>
                <a:rPr lang="en-US" altLang="zh-CN" dirty="0" smtClean="0">
                  <a:solidFill>
                    <a:schemeClr val="bg1"/>
                  </a:solidFill>
                </a:rPr>
                <a:t>0s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829321" y="4456289"/>
              <a:ext cx="936024" cy="4365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schemeClr val="bg1"/>
                  </a:solidFill>
                </a:rPr>
                <a:t>   50s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874464" y="1824998"/>
              <a:ext cx="426842" cy="4365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/>
                <a:t>A</a:t>
              </a:r>
              <a:endParaRPr lang="zh-CN" altLang="en-US" b="1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013975" y="2945382"/>
              <a:ext cx="611688" cy="437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schemeClr val="bg1"/>
                  </a:solidFill>
                </a:rPr>
                <a:t>0s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6016459" y="2945382"/>
              <a:ext cx="878391" cy="437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schemeClr val="bg1"/>
                  </a:solidFill>
                </a:rPr>
                <a:t>50s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092279" y="2945382"/>
              <a:ext cx="720000" cy="761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schemeClr val="bg1"/>
                  </a:solidFill>
                </a:rPr>
                <a:t>150s</a:t>
              </a:r>
            </a:p>
            <a:p>
              <a:endParaRPr lang="en-US" altLang="zh-CN" dirty="0" smtClean="0">
                <a:solidFill>
                  <a:schemeClr val="bg1"/>
                </a:solidFill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229029" y="1813564"/>
              <a:ext cx="721914" cy="4365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GSK</a:t>
              </a:r>
              <a:endParaRPr lang="zh-CN" altLang="en-US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211961" y="3329142"/>
              <a:ext cx="1960618" cy="4365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HC067047</a:t>
              </a:r>
              <a:endParaRPr lang="zh-CN" altLang="en-US" dirty="0"/>
            </a:p>
          </p:txBody>
        </p:sp>
      </p:grpSp>
      <p:sp>
        <p:nvSpPr>
          <p:cNvPr id="56" name="TextBox 55"/>
          <p:cNvSpPr txBox="1"/>
          <p:nvPr/>
        </p:nvSpPr>
        <p:spPr>
          <a:xfrm>
            <a:off x="114300" y="2974853"/>
            <a:ext cx="363256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 smtClean="0"/>
              <a:t>B</a:t>
            </a:r>
            <a:endParaRPr lang="zh-CN" altLang="en-US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6851449" y="1756970"/>
            <a:ext cx="363256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/>
              <a:t>D</a:t>
            </a:r>
            <a:endParaRPr lang="zh-CN" altLang="en-US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384859" y="685191"/>
            <a:ext cx="8799274" cy="567918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sz="3100" b="1" dirty="0"/>
              <a:t>Figure </a:t>
            </a:r>
            <a:r>
              <a:rPr lang="en-US" altLang="zh-CN" sz="3100" b="1" dirty="0" smtClean="0"/>
              <a:t>S2 </a:t>
            </a:r>
            <a:endParaRPr lang="zh-CN" altLang="en-US" sz="3100" b="1" dirty="0"/>
          </a:p>
        </p:txBody>
      </p:sp>
      <p:pic>
        <p:nvPicPr>
          <p:cNvPr id="5484" name="Picture 364" descr="C:\Users\apple\Desktop\图片1.pn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1849" y="1866770"/>
            <a:ext cx="3524483" cy="27429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85" name="Picture 365" descr="C:\Users\apple\Desktop\图片2.png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3926" y="2147933"/>
            <a:ext cx="3541483" cy="27124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67665287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384859" y="685191"/>
            <a:ext cx="8799274" cy="567918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sz="3100" b="1" dirty="0"/>
              <a:t>Figure </a:t>
            </a:r>
            <a:r>
              <a:rPr lang="en-US" altLang="zh-CN" sz="3100" b="1" dirty="0" smtClean="0"/>
              <a:t>S3 </a:t>
            </a:r>
            <a:endParaRPr lang="zh-CN" altLang="en-US" sz="3100" b="1" dirty="0"/>
          </a:p>
        </p:txBody>
      </p:sp>
      <p:grpSp>
        <p:nvGrpSpPr>
          <p:cNvPr id="2" name="组合 1"/>
          <p:cNvGrpSpPr/>
          <p:nvPr/>
        </p:nvGrpSpPr>
        <p:grpSpPr>
          <a:xfrm>
            <a:off x="855042" y="1619520"/>
            <a:ext cx="5013995" cy="3845304"/>
            <a:chOff x="855042" y="1619520"/>
            <a:chExt cx="5013995" cy="3845304"/>
          </a:xfrm>
        </p:grpSpPr>
        <p:cxnSp>
          <p:nvCxnSpPr>
            <p:cNvPr id="24" name="直接连接符 23"/>
            <p:cNvCxnSpPr/>
            <p:nvPr/>
          </p:nvCxnSpPr>
          <p:spPr>
            <a:xfrm>
              <a:off x="1506574" y="2984182"/>
              <a:ext cx="20450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1436900" y="1619520"/>
              <a:ext cx="535910" cy="353024"/>
            </a:xfrm>
            <a:prstGeom prst="rect">
              <a:avLst/>
            </a:prstGeom>
            <a:noFill/>
          </p:spPr>
          <p:txBody>
            <a:bodyPr wrap="square" lIns="91422" tIns="45711" rIns="91422" bIns="45711" rtlCol="0">
              <a:spAutoFit/>
            </a:bodyPr>
            <a:lstStyle/>
            <a:p>
              <a:r>
                <a:rPr lang="en-US" altLang="zh-CN" i="1" dirty="0" smtClean="0"/>
                <a:t>ctrl</a:t>
              </a:r>
              <a:endParaRPr lang="zh-CN" altLang="en-US" i="1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968068" y="1619520"/>
              <a:ext cx="993293" cy="353024"/>
            </a:xfrm>
            <a:prstGeom prst="rect">
              <a:avLst/>
            </a:prstGeom>
            <a:noFill/>
          </p:spPr>
          <p:txBody>
            <a:bodyPr wrap="square" lIns="91422" tIns="45711" rIns="91422" bIns="45711" rtlCol="0">
              <a:spAutoFit/>
            </a:bodyPr>
            <a:lstStyle/>
            <a:p>
              <a:r>
                <a:rPr lang="en-US" altLang="zh-CN" i="1" dirty="0" smtClean="0"/>
                <a:t>GSK</a:t>
              </a:r>
              <a:endParaRPr lang="zh-CN" altLang="en-US" i="1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414425" y="1636269"/>
              <a:ext cx="1454612" cy="353925"/>
            </a:xfrm>
            <a:prstGeom prst="rect">
              <a:avLst/>
            </a:prstGeom>
            <a:noFill/>
          </p:spPr>
          <p:txBody>
            <a:bodyPr wrap="square" lIns="91422" tIns="45711" rIns="91422" bIns="45711" rtlCol="0">
              <a:spAutoFit/>
            </a:bodyPr>
            <a:lstStyle/>
            <a:p>
              <a:r>
                <a:rPr lang="en-US" altLang="zh-CN" i="1" dirty="0" smtClean="0"/>
                <a:t>HC067047</a:t>
              </a:r>
              <a:endParaRPr lang="zh-CN" altLang="en-US" i="1" dirty="0"/>
            </a:p>
          </p:txBody>
        </p:sp>
        <p:cxnSp>
          <p:nvCxnSpPr>
            <p:cNvPr id="44" name="直接连接符 43"/>
            <p:cNvCxnSpPr/>
            <p:nvPr/>
          </p:nvCxnSpPr>
          <p:spPr>
            <a:xfrm>
              <a:off x="1481401" y="3056007"/>
              <a:ext cx="20450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grpSp>
          <p:nvGrpSpPr>
            <p:cNvPr id="14" name="组合 13"/>
            <p:cNvGrpSpPr/>
            <p:nvPr/>
          </p:nvGrpSpPr>
          <p:grpSpPr>
            <a:xfrm>
              <a:off x="855042" y="1997742"/>
              <a:ext cx="4821229" cy="1520350"/>
              <a:chOff x="791536" y="1711612"/>
              <a:chExt cx="3714585" cy="1081861"/>
            </a:xfrm>
          </p:grpSpPr>
          <p:pic>
            <p:nvPicPr>
              <p:cNvPr id="15" name="图片 14"/>
              <p:cNvPicPr>
                <a:picLocks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1536" y="1711612"/>
                <a:ext cx="1170490" cy="1080000"/>
              </a:xfrm>
              <a:prstGeom prst="rect">
                <a:avLst/>
              </a:prstGeom>
            </p:spPr>
          </p:pic>
          <p:pic>
            <p:nvPicPr>
              <p:cNvPr id="17" name="图片 16"/>
              <p:cNvPicPr>
                <a:picLocks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67567" y="1713473"/>
                <a:ext cx="1170489" cy="1080000"/>
              </a:xfrm>
              <a:prstGeom prst="rect">
                <a:avLst/>
              </a:prstGeom>
            </p:spPr>
          </p:pic>
          <p:pic>
            <p:nvPicPr>
              <p:cNvPr id="18" name="图片 17"/>
              <p:cNvPicPr>
                <a:picLocks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35632" y="1711612"/>
                <a:ext cx="1170489" cy="1080000"/>
              </a:xfrm>
              <a:prstGeom prst="rect">
                <a:avLst/>
              </a:prstGeom>
            </p:spPr>
          </p:pic>
          <p:cxnSp>
            <p:nvCxnSpPr>
              <p:cNvPr id="19" name="直接连接符 18"/>
              <p:cNvCxnSpPr/>
              <p:nvPr/>
            </p:nvCxnSpPr>
            <p:spPr>
              <a:xfrm>
                <a:off x="1708781" y="2723244"/>
                <a:ext cx="192347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accent3"/>
              </a:lnRef>
              <a:fillRef idx="0">
                <a:schemeClr val="accent3"/>
              </a:fillRef>
              <a:effectRef idx="2">
                <a:schemeClr val="accent3"/>
              </a:effectRef>
              <a:fontRef idx="minor">
                <a:schemeClr val="tx1"/>
              </a:fontRef>
            </p:style>
          </p:cxnSp>
        </p:grpSp>
        <p:pic>
          <p:nvPicPr>
            <p:cNvPr id="6264" name="Picture 120"/>
            <p:cNvPicPr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56128" y="3945624"/>
              <a:ext cx="1519200" cy="1519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265" name="Picture 121"/>
            <p:cNvPicPr>
              <a:picLocks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11227" y="3945608"/>
              <a:ext cx="1519200" cy="1519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TextBox 22"/>
            <p:cNvSpPr txBox="1"/>
            <p:nvPr/>
          </p:nvSpPr>
          <p:spPr>
            <a:xfrm>
              <a:off x="4234279" y="3621628"/>
              <a:ext cx="1353333" cy="615535"/>
            </a:xfrm>
            <a:prstGeom prst="rect">
              <a:avLst/>
            </a:prstGeom>
            <a:noFill/>
          </p:spPr>
          <p:txBody>
            <a:bodyPr wrap="square" lIns="91422" tIns="45711" rIns="91422" bIns="45711" rtlCol="0">
              <a:spAutoFit/>
            </a:bodyPr>
            <a:lstStyle/>
            <a:p>
              <a:r>
                <a:rPr lang="en-US" altLang="zh-CN" i="1" dirty="0" smtClean="0"/>
                <a:t>shRNA</a:t>
              </a:r>
              <a:r>
                <a:rPr lang="en-US" altLang="zh-CN" i="1" dirty="0"/>
                <a:t> +GSK</a:t>
              </a:r>
              <a:endParaRPr lang="zh-CN" altLang="en-US" i="1" dirty="0"/>
            </a:p>
            <a:p>
              <a:endParaRPr lang="zh-CN" altLang="en-US" i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859215" y="3607114"/>
              <a:ext cx="993293" cy="353024"/>
            </a:xfrm>
            <a:prstGeom prst="rect">
              <a:avLst/>
            </a:prstGeom>
            <a:noFill/>
          </p:spPr>
          <p:txBody>
            <a:bodyPr wrap="square" lIns="91422" tIns="45711" rIns="91422" bIns="45711" rtlCol="0">
              <a:spAutoFit/>
            </a:bodyPr>
            <a:lstStyle/>
            <a:p>
              <a:r>
                <a:rPr lang="en-US" altLang="zh-CN" i="1" dirty="0" smtClean="0"/>
                <a:t>shRNA</a:t>
              </a:r>
              <a:endParaRPr lang="zh-CN" altLang="en-US" i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05117" y="3584914"/>
              <a:ext cx="1591596" cy="360694"/>
            </a:xfrm>
            <a:prstGeom prst="rect">
              <a:avLst/>
            </a:prstGeom>
            <a:noFill/>
          </p:spPr>
          <p:txBody>
            <a:bodyPr wrap="square" lIns="91422" tIns="45711" rIns="91422" bIns="45711" rtlCol="0">
              <a:spAutoFit/>
            </a:bodyPr>
            <a:lstStyle/>
            <a:p>
              <a:r>
                <a:rPr lang="en-US" altLang="zh-CN" i="1" dirty="0" smtClean="0"/>
                <a:t>HC067047+GSK</a:t>
              </a:r>
              <a:endParaRPr lang="zh-CN" altLang="en-US" i="1" dirty="0"/>
            </a:p>
          </p:txBody>
        </p:sp>
        <p:pic>
          <p:nvPicPr>
            <p:cNvPr id="6273" name="Picture 129"/>
            <p:cNvPicPr>
              <a:picLocks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3739" y="3945624"/>
              <a:ext cx="1519200" cy="1519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6330" name="Picture 186" descr="C:\Users\apple\Desktop\图片3.pn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368" y="1980109"/>
            <a:ext cx="2742973" cy="34439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450825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55"/>
          <p:cNvSpPr txBox="1"/>
          <p:nvPr/>
        </p:nvSpPr>
        <p:spPr>
          <a:xfrm>
            <a:off x="0" y="-31416"/>
            <a:ext cx="535910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i="1" dirty="0" smtClean="0"/>
              <a:t>ctrl</a:t>
            </a:r>
            <a:endParaRPr lang="zh-CN" altLang="en-US" i="1" dirty="0"/>
          </a:p>
        </p:txBody>
      </p:sp>
      <p:sp>
        <p:nvSpPr>
          <p:cNvPr id="57" name="TextBox 56"/>
          <p:cNvSpPr txBox="1"/>
          <p:nvPr/>
        </p:nvSpPr>
        <p:spPr>
          <a:xfrm>
            <a:off x="-68795" y="2836933"/>
            <a:ext cx="993293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i="1" dirty="0" smtClean="0"/>
              <a:t>GSK</a:t>
            </a:r>
            <a:endParaRPr lang="zh-CN" altLang="en-US" i="1" dirty="0"/>
          </a:p>
        </p:txBody>
      </p:sp>
      <p:sp>
        <p:nvSpPr>
          <p:cNvPr id="58" name="TextBox 57"/>
          <p:cNvSpPr txBox="1"/>
          <p:nvPr/>
        </p:nvSpPr>
        <p:spPr>
          <a:xfrm>
            <a:off x="-93339" y="1460061"/>
            <a:ext cx="1454612" cy="353925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i="1" dirty="0" smtClean="0"/>
              <a:t>HC067047</a:t>
            </a:r>
            <a:endParaRPr lang="zh-CN" altLang="en-US" i="1" dirty="0"/>
          </a:p>
        </p:txBody>
      </p:sp>
      <p:sp>
        <p:nvSpPr>
          <p:cNvPr id="23" name="TextBox 22"/>
          <p:cNvSpPr txBox="1"/>
          <p:nvPr/>
        </p:nvSpPr>
        <p:spPr>
          <a:xfrm>
            <a:off x="7539508" y="2935"/>
            <a:ext cx="1353333" cy="615535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i="1" dirty="0" smtClean="0"/>
              <a:t>shRNA</a:t>
            </a:r>
            <a:r>
              <a:rPr lang="en-US" altLang="zh-CN" i="1" dirty="0"/>
              <a:t> +GSK</a:t>
            </a:r>
            <a:endParaRPr lang="zh-CN" altLang="en-US" i="1" dirty="0"/>
          </a:p>
          <a:p>
            <a:endParaRPr lang="zh-CN" altLang="en-US" i="1" dirty="0"/>
          </a:p>
        </p:txBody>
      </p:sp>
      <p:grpSp>
        <p:nvGrpSpPr>
          <p:cNvPr id="3" name="组合 2"/>
          <p:cNvGrpSpPr/>
          <p:nvPr/>
        </p:nvGrpSpPr>
        <p:grpSpPr>
          <a:xfrm>
            <a:off x="-21899" y="5407629"/>
            <a:ext cx="4630672" cy="1410736"/>
            <a:chOff x="267955" y="2621477"/>
            <a:chExt cx="4630672" cy="1410736"/>
          </a:xfrm>
        </p:grpSpPr>
        <p:sp>
          <p:nvSpPr>
            <p:cNvPr id="25" name="TextBox 24"/>
            <p:cNvSpPr txBox="1"/>
            <p:nvPr/>
          </p:nvSpPr>
          <p:spPr>
            <a:xfrm>
              <a:off x="267955" y="2621477"/>
              <a:ext cx="993293" cy="353024"/>
            </a:xfrm>
            <a:prstGeom prst="rect">
              <a:avLst/>
            </a:prstGeom>
            <a:noFill/>
          </p:spPr>
          <p:txBody>
            <a:bodyPr wrap="square" lIns="91422" tIns="45711" rIns="91422" bIns="45711" rtlCol="0">
              <a:spAutoFit/>
            </a:bodyPr>
            <a:lstStyle/>
            <a:p>
              <a:r>
                <a:rPr lang="en-US" altLang="zh-CN" i="1" dirty="0" smtClean="0"/>
                <a:t>shRNA</a:t>
              </a:r>
              <a:endParaRPr lang="zh-CN" altLang="en-US" i="1" dirty="0"/>
            </a:p>
          </p:txBody>
        </p:sp>
        <p:pic>
          <p:nvPicPr>
            <p:cNvPr id="9218" name="Picture 2"/>
            <p:cNvPicPr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478371" y="2909197"/>
              <a:ext cx="1116000" cy="111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219" name="Picture 3"/>
            <p:cNvPicPr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30499" y="2916213"/>
              <a:ext cx="1116000" cy="111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" name="Picture 121"/>
            <p:cNvPicPr>
              <a:picLocks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4421" y="2916212"/>
              <a:ext cx="1116000" cy="111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221" name="Picture 5"/>
            <p:cNvPicPr>
              <a:picLocks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82627" y="2909197"/>
              <a:ext cx="1116000" cy="111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0" name="TextBox 29"/>
          <p:cNvSpPr txBox="1"/>
          <p:nvPr/>
        </p:nvSpPr>
        <p:spPr>
          <a:xfrm>
            <a:off x="-49907" y="4125493"/>
            <a:ext cx="1591596" cy="36069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i="1" dirty="0" smtClean="0"/>
              <a:t>HC067047+GSK</a:t>
            </a:r>
            <a:endParaRPr lang="zh-CN" altLang="en-US" i="1" dirty="0"/>
          </a:p>
        </p:txBody>
      </p:sp>
      <p:pic>
        <p:nvPicPr>
          <p:cNvPr id="9233" name="Picture 17"/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61" y="177837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35" name="Picture 19"/>
          <p:cNvPicPr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4445" y="177837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36" name="Picture 20"/>
          <p:cNvPicPr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0893" y="177837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39" name="Picture 23"/>
          <p:cNvPicPr>
            <a:picLocks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2453" y="177837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图片 47"/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51" y="251917"/>
            <a:ext cx="1116000" cy="1116000"/>
          </a:xfrm>
          <a:prstGeom prst="rect">
            <a:avLst/>
          </a:prstGeom>
        </p:spPr>
      </p:pic>
      <p:pic>
        <p:nvPicPr>
          <p:cNvPr id="9240" name="Picture 24"/>
          <p:cNvPicPr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8518" y="25576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43" name="Picture 27"/>
          <p:cNvPicPr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901" y="250168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44" name="Picture 28"/>
          <p:cNvPicPr>
            <a:picLocks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colorTemperature colorTemp="72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5469" y="250168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46" name="Picture 30"/>
          <p:cNvPicPr>
            <a:picLocks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6027" y="3119626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9" name="图片 58"/>
          <p:cNvPicPr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88" y="3110645"/>
            <a:ext cx="1116000" cy="1116000"/>
          </a:xfrm>
          <a:prstGeom prst="rect">
            <a:avLst/>
          </a:prstGeom>
        </p:spPr>
      </p:pic>
      <p:pic>
        <p:nvPicPr>
          <p:cNvPr id="9247" name="Picture 31"/>
          <p:cNvPicPr>
            <a:picLocks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3677" y="3109552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48" name="Picture 32"/>
          <p:cNvPicPr>
            <a:picLocks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333" y="310912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49" name="Picture 33"/>
          <p:cNvPicPr>
            <a:picLocks noChangeArrowheads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6037" y="3109552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50" name="Picture 34"/>
          <p:cNvPicPr>
            <a:picLocks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6817" y="5703501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4" name="Picture 129"/>
          <p:cNvPicPr>
            <a:picLocks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03" y="4405004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52" name="Picture 36"/>
          <p:cNvPicPr>
            <a:picLocks noChangeArrowheads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colorTemperature colorTemp="5200"/>
                    </a14:imgEffect>
                    <a14:imgEffect>
                      <a14:brightnessContrast brigh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7645" y="4405004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54" name="Picture 38"/>
          <p:cNvPicPr>
            <a:picLocks noChangeArrowheads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colorTemperature colorTemp="5400"/>
                    </a14:imgEffect>
                    <a14:imgEffect>
                      <a14:brightnessContrast bright="-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4613" y="4405004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56" name="Picture 40"/>
          <p:cNvPicPr>
            <a:picLocks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6741" y="4405004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57" name="Picture 41"/>
          <p:cNvPicPr>
            <a:picLocks noChangeArrowheads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-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996" y="177837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58" name="Picture 42"/>
          <p:cNvPicPr>
            <a:picLocks noChangeArrowheads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9192" y="4399014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59" name="Picture 43"/>
          <p:cNvPicPr>
            <a:picLocks noChangeArrowheads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0645" y="256380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62" name="Picture 46"/>
          <p:cNvPicPr>
            <a:picLocks noChangeArrowheads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9309" y="1507837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63" name="Picture 47"/>
          <p:cNvPicPr>
            <a:picLocks noChangeArrowheads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75759" y="319494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64" name="Picture 48"/>
          <p:cNvPicPr>
            <a:picLocks noChangeArrowheads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23597" y="2664309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66" name="Picture 50"/>
          <p:cNvPicPr>
            <a:picLocks noChangeArrowheads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8467234" y="149723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68" name="Picture 52"/>
          <p:cNvPicPr>
            <a:picLocks noChangeArrowheads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75759" y="2649255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" name="Picture 120"/>
          <p:cNvPicPr>
            <a:picLocks noChangeArrowheads="1"/>
          </p:cNvPicPr>
          <p:nvPr/>
        </p:nvPicPr>
        <p:blipFill>
          <a:blip r:embed="rId41" cstate="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colorTemperature colorTemp="8100"/>
                    </a14:imgEffect>
                    <a14:imgEffect>
                      <a14:saturation sat="99000"/>
                    </a14:imgEffect>
                    <a14:imgEffect>
                      <a14:brightnessContrast bright="2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9529" y="338671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69" name="Picture 53"/>
          <p:cNvPicPr>
            <a:picLocks noChangeArrowheads="1"/>
          </p:cNvPicPr>
          <p:nvPr/>
        </p:nvPicPr>
        <p:blipFill>
          <a:blip r:embed="rId43" cstate="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-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1317" y="177837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71" name="Picture 55"/>
          <p:cNvPicPr>
            <a:picLocks noChangeArrowheads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7029" y="261911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72" name="Picture 56"/>
          <p:cNvPicPr>
            <a:picLocks noChangeArrowheads="1"/>
          </p:cNvPicPr>
          <p:nvPr/>
        </p:nvPicPr>
        <p:blipFill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colorTemperature colorTemp="6000"/>
                    </a14:imgEffect>
                    <a14:imgEffect>
                      <a14:brightnessContrast bright="-17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7029" y="3113979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73" name="Picture 57"/>
          <p:cNvPicPr>
            <a:picLocks noChangeArrowheads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27125" y="4394277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74" name="Picture 58"/>
          <p:cNvPicPr>
            <a:picLocks noChangeArrowheads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33157" y="5702933"/>
            <a:ext cx="1116000" cy="11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539508" y="4486187"/>
            <a:ext cx="2182342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Transwell</a:t>
            </a:r>
            <a:r>
              <a:rPr lang="en-US" altLang="zh-CN" dirty="0" smtClean="0"/>
              <a:t> raw materials</a:t>
            </a:r>
          </a:p>
          <a:p>
            <a:endParaRPr lang="en-US" altLang="zh-CN" dirty="0"/>
          </a:p>
          <a:p>
            <a:r>
              <a:rPr lang="en-US" altLang="zh-CN" dirty="0" smtClean="0"/>
              <a:t>Every first image is what I used in the article.</a:t>
            </a:r>
          </a:p>
          <a:p>
            <a:endParaRPr lang="en-US" altLang="zh-CN" dirty="0"/>
          </a:p>
          <a:p>
            <a:endParaRPr lang="zh-CN" alt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8784983" y="2935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50" name="TextBox 49"/>
          <p:cNvSpPr txBox="1"/>
          <p:nvPr/>
        </p:nvSpPr>
        <p:spPr>
          <a:xfrm>
            <a:off x="864103" y="1454014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51" name="TextBox 50"/>
          <p:cNvSpPr txBox="1"/>
          <p:nvPr/>
        </p:nvSpPr>
        <p:spPr>
          <a:xfrm>
            <a:off x="443775" y="2828469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52" name="TextBox 51"/>
          <p:cNvSpPr txBox="1"/>
          <p:nvPr/>
        </p:nvSpPr>
        <p:spPr>
          <a:xfrm>
            <a:off x="1296151" y="4118310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53" name="TextBox 52"/>
          <p:cNvSpPr txBox="1"/>
          <p:nvPr/>
        </p:nvSpPr>
        <p:spPr>
          <a:xfrm>
            <a:off x="584455" y="5414454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54" name="TextBox 53"/>
          <p:cNvSpPr txBox="1"/>
          <p:nvPr/>
        </p:nvSpPr>
        <p:spPr>
          <a:xfrm>
            <a:off x="584455" y="116285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448345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49" name="Picture 81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4552" y="1713724"/>
            <a:ext cx="1508400" cy="1155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85" name="Picture 17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3534" y="1713724"/>
            <a:ext cx="1508035" cy="1152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矩形 7"/>
          <p:cNvSpPr/>
          <p:nvPr/>
        </p:nvSpPr>
        <p:spPr>
          <a:xfrm flipV="1">
            <a:off x="2841721" y="2832680"/>
            <a:ext cx="116759" cy="787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91422" tIns="45711" rIns="91422" bIns="45711"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4552" y="3214339"/>
            <a:ext cx="1508318" cy="1152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775227" y="1366602"/>
            <a:ext cx="1378053" cy="613968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err="1" smtClean="0"/>
              <a:t>Ctl</a:t>
            </a:r>
            <a:endParaRPr lang="en-US" altLang="zh-CN" dirty="0" smtClean="0"/>
          </a:p>
          <a:p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657880" y="2860966"/>
            <a:ext cx="1378053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/>
              <a:t>HC067047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291563" y="1372987"/>
            <a:ext cx="1515858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/>
              <a:t>GSK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1355518" y="1386983"/>
            <a:ext cx="453817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 smtClean="0"/>
              <a:t>A</a:t>
            </a:r>
            <a:endParaRPr lang="zh-CN" alt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906834" y="1372987"/>
            <a:ext cx="453817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333342" y="2860966"/>
            <a:ext cx="453817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/>
              <a:t>C</a:t>
            </a:r>
            <a:endParaRPr lang="zh-CN" altLang="en-US" b="1" dirty="0"/>
          </a:p>
        </p:txBody>
      </p:sp>
      <p:sp>
        <p:nvSpPr>
          <p:cNvPr id="20" name="矩形 19"/>
          <p:cNvSpPr/>
          <p:nvPr/>
        </p:nvSpPr>
        <p:spPr>
          <a:xfrm flipV="1">
            <a:off x="4414968" y="2832680"/>
            <a:ext cx="116759" cy="787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91422" tIns="45711" rIns="91422" bIns="45711"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 flipV="1">
            <a:off x="2821305" y="4360467"/>
            <a:ext cx="116759" cy="787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91422" tIns="45711" rIns="91422" bIns="45711"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/>
          </a:p>
        </p:txBody>
      </p:sp>
      <p:sp>
        <p:nvSpPr>
          <p:cNvPr id="24" name="TextBox 23"/>
          <p:cNvSpPr txBox="1"/>
          <p:nvPr/>
        </p:nvSpPr>
        <p:spPr>
          <a:xfrm>
            <a:off x="3175989" y="2860966"/>
            <a:ext cx="1631432" cy="353925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/>
              <a:t>HC067047+GSK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2859847" y="2875913"/>
            <a:ext cx="453817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/>
              <a:t>D</a:t>
            </a:r>
            <a:endParaRPr lang="zh-CN" altLang="en-US" b="1" dirty="0"/>
          </a:p>
        </p:txBody>
      </p:sp>
      <p:pic>
        <p:nvPicPr>
          <p:cNvPr id="7178" name="Picture 10"/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3534" y="3214334"/>
            <a:ext cx="1508035" cy="1152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矩形 25"/>
          <p:cNvSpPr/>
          <p:nvPr/>
        </p:nvSpPr>
        <p:spPr>
          <a:xfrm flipV="1">
            <a:off x="4359620" y="4340799"/>
            <a:ext cx="116759" cy="787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91422" tIns="45711" rIns="91422" bIns="45711"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/>
          </a:p>
        </p:txBody>
      </p:sp>
      <p:sp>
        <p:nvSpPr>
          <p:cNvPr id="21" name="TextBox 20"/>
          <p:cNvSpPr txBox="1"/>
          <p:nvPr/>
        </p:nvSpPr>
        <p:spPr>
          <a:xfrm>
            <a:off x="384859" y="685191"/>
            <a:ext cx="8799274" cy="567918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sz="3100" b="1" dirty="0"/>
              <a:t>Figure </a:t>
            </a:r>
            <a:r>
              <a:rPr lang="en-US" altLang="zh-CN" sz="3100" b="1" dirty="0" smtClean="0"/>
              <a:t>S4 </a:t>
            </a:r>
            <a:endParaRPr lang="zh-CN" altLang="en-US" sz="3100" b="1" dirty="0"/>
          </a:p>
        </p:txBody>
      </p:sp>
      <p:pic>
        <p:nvPicPr>
          <p:cNvPr id="7255" name="Picture 87"/>
          <p:cNvPicPr>
            <a:picLocks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4831" y="4712941"/>
            <a:ext cx="1508400" cy="1155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1657071" y="4394757"/>
            <a:ext cx="1378053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/>
              <a:t>shRNA</a:t>
            </a:r>
            <a:endParaRPr lang="zh-CN" alt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1332533" y="4394757"/>
            <a:ext cx="453817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/>
              <a:t>E</a:t>
            </a:r>
            <a:endParaRPr lang="zh-CN" altLang="en-US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3174233" y="4356853"/>
            <a:ext cx="1391521" cy="353925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err="1" smtClean="0"/>
              <a:t>shRNA+GSK</a:t>
            </a:r>
            <a:endParaRPr lang="zh-CN" alt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2858091" y="4371800"/>
            <a:ext cx="453817" cy="3530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b="1" dirty="0"/>
              <a:t>F</a:t>
            </a:r>
            <a:endParaRPr lang="zh-CN" altLang="en-US" b="1" dirty="0"/>
          </a:p>
        </p:txBody>
      </p:sp>
      <p:pic>
        <p:nvPicPr>
          <p:cNvPr id="7260" name="Picture 92" descr="C:\Users\apple\Desktop\HRCECs shRNA成管\gsk+shrna\1 (2).jpg"/>
          <p:cNvPicPr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4493" y="4716541"/>
            <a:ext cx="1508400" cy="115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340" name="Picture 172" descr="C:\Users\apple\Desktop\图片4.pn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917" y="1550654"/>
            <a:ext cx="3139181" cy="44619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040547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81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09" y="17990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7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89" y="1447917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7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60" y="272999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>
            <a:spLocks/>
          </p:cNvSpPr>
          <p:nvPr/>
        </p:nvSpPr>
        <p:spPr>
          <a:xfrm>
            <a:off x="-79491" y="-94055"/>
            <a:ext cx="1080000" cy="1080000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err="1" smtClean="0"/>
              <a:t>Ctl</a:t>
            </a:r>
            <a:endParaRPr lang="en-US" altLang="zh-CN" dirty="0" smtClean="0"/>
          </a:p>
          <a:p>
            <a:endParaRPr lang="zh-CN" altLang="en-US" dirty="0"/>
          </a:p>
        </p:txBody>
      </p:sp>
      <p:sp>
        <p:nvSpPr>
          <p:cNvPr id="9" name="TextBox 8"/>
          <p:cNvSpPr txBox="1">
            <a:spLocks/>
          </p:cNvSpPr>
          <p:nvPr/>
        </p:nvSpPr>
        <p:spPr>
          <a:xfrm>
            <a:off x="-89189" y="2456029"/>
            <a:ext cx="1567406" cy="353925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/>
              <a:t>HC067047</a:t>
            </a:r>
            <a:endParaRPr lang="zh-CN" altLang="en-US" dirty="0"/>
          </a:p>
        </p:txBody>
      </p:sp>
      <p:sp>
        <p:nvSpPr>
          <p:cNvPr id="10" name="TextBox 9"/>
          <p:cNvSpPr txBox="1">
            <a:spLocks/>
          </p:cNvSpPr>
          <p:nvPr/>
        </p:nvSpPr>
        <p:spPr>
          <a:xfrm>
            <a:off x="-107627" y="1188021"/>
            <a:ext cx="1080000" cy="1080000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/>
              <a:t>GSK</a:t>
            </a:r>
            <a:endParaRPr lang="zh-CN" altLang="en-US" dirty="0"/>
          </a:p>
        </p:txBody>
      </p:sp>
      <p:sp>
        <p:nvSpPr>
          <p:cNvPr id="16" name="TextBox 15"/>
          <p:cNvSpPr txBox="1">
            <a:spLocks/>
          </p:cNvSpPr>
          <p:nvPr/>
        </p:nvSpPr>
        <p:spPr>
          <a:xfrm>
            <a:off x="-107627" y="3708301"/>
            <a:ext cx="2376264" cy="353925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/>
              <a:t>HC067047+GSK</a:t>
            </a:r>
            <a:endParaRPr lang="zh-CN" altLang="en-US" dirty="0"/>
          </a:p>
        </p:txBody>
      </p:sp>
      <p:pic>
        <p:nvPicPr>
          <p:cNvPr id="18" name="Picture 10"/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74" y="399645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87"/>
          <p:cNvPicPr>
            <a:picLocks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71" y="5292477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TextBox 20"/>
          <p:cNvSpPr txBox="1">
            <a:spLocks/>
          </p:cNvSpPr>
          <p:nvPr/>
        </p:nvSpPr>
        <p:spPr>
          <a:xfrm>
            <a:off x="-86397" y="5004445"/>
            <a:ext cx="1080000" cy="1080000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smtClean="0"/>
              <a:t>shRNA</a:t>
            </a:r>
            <a:endParaRPr lang="zh-CN" altLang="en-US" dirty="0"/>
          </a:p>
        </p:txBody>
      </p:sp>
      <p:sp>
        <p:nvSpPr>
          <p:cNvPr id="23" name="TextBox 22"/>
          <p:cNvSpPr txBox="1">
            <a:spLocks/>
          </p:cNvSpPr>
          <p:nvPr/>
        </p:nvSpPr>
        <p:spPr>
          <a:xfrm>
            <a:off x="7021165" y="-92716"/>
            <a:ext cx="1570885" cy="353925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zh-CN" dirty="0" err="1" smtClean="0"/>
              <a:t>shRNA+GSK</a:t>
            </a:r>
            <a:endParaRPr lang="zh-CN" altLang="en-US" dirty="0"/>
          </a:p>
        </p:txBody>
      </p:sp>
      <p:pic>
        <p:nvPicPr>
          <p:cNvPr id="25" name="Picture 92" descr="C:\Users\apple\Desktop\HRCECs shRNA成管\gsk+shrna\1 (2).jpg"/>
          <p:cNvPicPr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50667" y="179909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2" name="Picture 2"/>
          <p:cNvPicPr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0501" y="17990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3" name="Picture 3"/>
          <p:cNvPicPr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4373" y="17990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4" name="Picture 4"/>
          <p:cNvPicPr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0297" y="17990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5" name="Picture 5"/>
          <p:cNvPicPr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4953" y="187794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6" name="Picture 6"/>
          <p:cNvPicPr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945" y="17990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7" name="Picture 7"/>
          <p:cNvPicPr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4449" y="5286768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8" name="Picture 8"/>
          <p:cNvPicPr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3270" y="530548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9" name="Picture 9"/>
          <p:cNvPicPr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6697" y="5298812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0" name="Picture 10"/>
          <p:cNvPicPr>
            <a:picLocks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7613" y="5300836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1" name="Picture 11"/>
          <p:cNvPicPr>
            <a:picLocks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9344" y="5306545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2" name="Picture 12"/>
          <p:cNvPicPr>
            <a:picLocks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50667" y="130568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3" name="Picture 13"/>
          <p:cNvPicPr>
            <a:picLocks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50667" y="2431271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4" name="Picture 14"/>
          <p:cNvPicPr>
            <a:picLocks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2871" y="17990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5" name="Picture 15"/>
          <p:cNvPicPr>
            <a:picLocks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82792" y="130568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6" name="Picture 16"/>
          <p:cNvPicPr>
            <a:picLocks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82792" y="244029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7" name="Picture 17"/>
          <p:cNvPicPr>
            <a:picLocks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0501" y="1458769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8" name="Picture 18"/>
          <p:cNvPicPr>
            <a:picLocks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4493" y="1461985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9" name="Picture 19"/>
          <p:cNvPicPr>
            <a:picLocks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8488" y="1461985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0" name="Picture 20"/>
          <p:cNvPicPr>
            <a:picLocks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7140" y="1461985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1" name="Picture 21"/>
          <p:cNvPicPr>
            <a:picLocks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2281" y="1463687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2" name="Picture 22"/>
          <p:cNvPicPr>
            <a:picLocks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1908" y="272999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3" name="Picture 23"/>
          <p:cNvPicPr>
            <a:picLocks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3115" y="272999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4" name="Picture 24"/>
          <p:cNvPicPr>
            <a:picLocks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9477" y="273011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5" name="Picture 25"/>
          <p:cNvPicPr>
            <a:picLocks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34461" y="272999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6" name="Picture 26"/>
          <p:cNvPicPr>
            <a:picLocks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3133" y="273011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7" name="Picture 27"/>
          <p:cNvPicPr>
            <a:picLocks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4449" y="399645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8" name="Picture 28"/>
          <p:cNvPicPr>
            <a:picLocks noChangeArrowheads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8561" y="399645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9" name="Picture 29"/>
          <p:cNvPicPr>
            <a:picLocks noChangeArrowheads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9477" y="4000027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0" name="Picture 30"/>
          <p:cNvPicPr>
            <a:picLocks noChangeArrowheads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7859" y="399645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1" name="Picture 31"/>
          <p:cNvPicPr>
            <a:picLocks noChangeArrowheads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9021" y="399645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7399565" y="4072957"/>
            <a:ext cx="1662204" cy="2446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Tube formation raw materials</a:t>
            </a:r>
          </a:p>
          <a:p>
            <a:endParaRPr lang="en-US" altLang="zh-CN" dirty="0"/>
          </a:p>
          <a:p>
            <a:endParaRPr lang="en-US" altLang="zh-CN" dirty="0" smtClean="0"/>
          </a:p>
          <a:p>
            <a:r>
              <a:rPr lang="en-US" altLang="zh-CN" dirty="0"/>
              <a:t>Every first image is what I used in the article.</a:t>
            </a:r>
          </a:p>
          <a:p>
            <a:endParaRPr lang="en-US" altLang="zh-CN" dirty="0" smtClean="0"/>
          </a:p>
          <a:p>
            <a:endParaRPr lang="zh-CN" alt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263239" y="-67587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46" name="TextBox 45"/>
          <p:cNvSpPr txBox="1"/>
          <p:nvPr/>
        </p:nvSpPr>
        <p:spPr>
          <a:xfrm>
            <a:off x="277307" y="1194118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47" name="TextBox 46"/>
          <p:cNvSpPr txBox="1"/>
          <p:nvPr/>
        </p:nvSpPr>
        <p:spPr>
          <a:xfrm>
            <a:off x="797823" y="2474526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48" name="TextBox 47"/>
          <p:cNvSpPr txBox="1"/>
          <p:nvPr/>
        </p:nvSpPr>
        <p:spPr>
          <a:xfrm>
            <a:off x="1260525" y="3712730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49" name="TextBox 48"/>
          <p:cNvSpPr txBox="1"/>
          <p:nvPr/>
        </p:nvSpPr>
        <p:spPr>
          <a:xfrm>
            <a:off x="516463" y="5010542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  <p:sp>
        <p:nvSpPr>
          <p:cNvPr id="50" name="TextBox 49"/>
          <p:cNvSpPr txBox="1"/>
          <p:nvPr/>
        </p:nvSpPr>
        <p:spPr>
          <a:xfrm>
            <a:off x="8122843" y="-94055"/>
            <a:ext cx="97248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n=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126225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81</TotalTime>
  <Words>127</Words>
  <Application>Microsoft Office PowerPoint</Application>
  <PresentationFormat>Custom</PresentationFormat>
  <Paragraphs>80</Paragraphs>
  <Slides>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</dc:creator>
  <cp:lastModifiedBy>Balindan, Danica Joy</cp:lastModifiedBy>
  <cp:revision>163</cp:revision>
  <dcterms:created xsi:type="dcterms:W3CDTF">2017-04-27T03:32:14Z</dcterms:created>
  <dcterms:modified xsi:type="dcterms:W3CDTF">2018-02-02T03:08:27Z</dcterms:modified>
</cp:coreProperties>
</file>